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7504" autoAdjust="0"/>
  </p:normalViewPr>
  <p:slideViewPr>
    <p:cSldViewPr snapToGrid="0" snapToObjects="1" showGuides="1">
      <p:cViewPr>
        <p:scale>
          <a:sx n="103" d="100"/>
          <a:sy n="103" d="100"/>
        </p:scale>
        <p:origin x="-1368" y="1592"/>
      </p:cViewPr>
      <p:guideLst>
        <p:guide orient="horz" pos="3234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SSD:Users:JamesP:Desktop:S3AB%20q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41937664041995"/>
          <c:y val="0.0319616427614598"/>
          <c:w val="0.830037182852143"/>
          <c:h val="0.6314235305649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0110106qPCR Pst hrc 6hpi'!$N$9</c:f>
              <c:strCache>
                <c:ptCount val="1"/>
                <c:pt idx="0">
                  <c:v>SlSERK3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110106qPCR Pst hrc 6hpi'!$N$25:$N$37</c:f>
                <c:numCache>
                  <c:formatCode>General</c:formatCode>
                  <c:ptCount val="13"/>
                  <c:pt idx="0">
                    <c:v>0.104159504728507</c:v>
                  </c:pt>
                  <c:pt idx="1">
                    <c:v>0.0633412790400131</c:v>
                  </c:pt>
                  <c:pt idx="2">
                    <c:v>0.0423019036595043</c:v>
                  </c:pt>
                  <c:pt idx="3">
                    <c:v>0.0103119472032136</c:v>
                  </c:pt>
                  <c:pt idx="4">
                    <c:v>0.0299119629347353</c:v>
                  </c:pt>
                  <c:pt idx="5">
                    <c:v>0.125340412972313</c:v>
                  </c:pt>
                  <c:pt idx="6">
                    <c:v>0.111635393038939</c:v>
                  </c:pt>
                  <c:pt idx="7">
                    <c:v>0.0647247183519376</c:v>
                  </c:pt>
                  <c:pt idx="8">
                    <c:v>0.142286076582741</c:v>
                  </c:pt>
                  <c:pt idx="9">
                    <c:v>0.00827472834586973</c:v>
                  </c:pt>
                  <c:pt idx="10">
                    <c:v>0.0</c:v>
                  </c:pt>
                  <c:pt idx="11">
                    <c:v>0.00897168281703675</c:v>
                  </c:pt>
                  <c:pt idx="12">
                    <c:v>0.0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strRef>
              <c:f>'20110106qPCR Pst hrc 6hpi'!$M$10:$M$22</c:f>
              <c:strCache>
                <c:ptCount val="13"/>
                <c:pt idx="0">
                  <c:v>TRV</c:v>
                </c:pt>
                <c:pt idx="1">
                  <c:v>S3A-3</c:v>
                </c:pt>
                <c:pt idx="2">
                  <c:v>S3A-4</c:v>
                </c:pt>
                <c:pt idx="3">
                  <c:v>S3A-5</c:v>
                </c:pt>
                <c:pt idx="4">
                  <c:v>S3A-6</c:v>
                </c:pt>
                <c:pt idx="5">
                  <c:v>S3B-3</c:v>
                </c:pt>
                <c:pt idx="6">
                  <c:v>S3B-4</c:v>
                </c:pt>
                <c:pt idx="7">
                  <c:v>S3B-5</c:v>
                </c:pt>
                <c:pt idx="8">
                  <c:v>S3B-6</c:v>
                </c:pt>
                <c:pt idx="9">
                  <c:v>S3AB-3</c:v>
                </c:pt>
                <c:pt idx="10">
                  <c:v>S3AB-4</c:v>
                </c:pt>
                <c:pt idx="11">
                  <c:v>S3AB-5</c:v>
                </c:pt>
                <c:pt idx="12">
                  <c:v>S3AB-6</c:v>
                </c:pt>
              </c:strCache>
            </c:strRef>
          </c:cat>
          <c:val>
            <c:numRef>
              <c:f>'20110106qPCR Pst hrc 6hpi'!$N$10:$N$22</c:f>
              <c:numCache>
                <c:formatCode>General</c:formatCode>
                <c:ptCount val="13"/>
                <c:pt idx="0">
                  <c:v>1.005409967339339</c:v>
                </c:pt>
                <c:pt idx="1">
                  <c:v>0.11966943295319</c:v>
                </c:pt>
                <c:pt idx="2">
                  <c:v>0.408323327645911</c:v>
                </c:pt>
                <c:pt idx="3">
                  <c:v>0.149008131211694</c:v>
                </c:pt>
                <c:pt idx="4">
                  <c:v>0.28872819389508</c:v>
                </c:pt>
                <c:pt idx="5">
                  <c:v>0.909924510869065</c:v>
                </c:pt>
                <c:pt idx="6">
                  <c:v>1.077571721963784</c:v>
                </c:pt>
                <c:pt idx="7">
                  <c:v>0.93527528164806</c:v>
                </c:pt>
                <c:pt idx="8">
                  <c:v>1.373430489927658</c:v>
                </c:pt>
                <c:pt idx="9">
                  <c:v>0.238853776742355</c:v>
                </c:pt>
                <c:pt idx="10">
                  <c:v>0.349492483544755</c:v>
                </c:pt>
                <c:pt idx="11">
                  <c:v>0.258971682817036</c:v>
                </c:pt>
                <c:pt idx="12">
                  <c:v>0.267943365634074</c:v>
                </c:pt>
              </c:numCache>
            </c:numRef>
          </c:val>
        </c:ser>
        <c:ser>
          <c:idx val="1"/>
          <c:order val="1"/>
          <c:tx>
            <c:strRef>
              <c:f>'20110106qPCR Pst hrc 6hpi'!$O$9</c:f>
              <c:strCache>
                <c:ptCount val="1"/>
                <c:pt idx="0">
                  <c:v>SlSERK3B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20110106qPCR Pst hrc 6hpi'!$O$25:$O$37</c:f>
                <c:numCache>
                  <c:formatCode>General</c:formatCode>
                  <c:ptCount val="13"/>
                  <c:pt idx="0">
                    <c:v>0.104159504728506</c:v>
                  </c:pt>
                  <c:pt idx="1">
                    <c:v>0.0625199568355653</c:v>
                  </c:pt>
                  <c:pt idx="2">
                    <c:v>0.198992305090874</c:v>
                  </c:pt>
                  <c:pt idx="3">
                    <c:v>0.0971842542938314</c:v>
                  </c:pt>
                  <c:pt idx="4">
                    <c:v>0.0281561586784812</c:v>
                  </c:pt>
                  <c:pt idx="5">
                    <c:v>0.00928806852830827</c:v>
                  </c:pt>
                  <c:pt idx="6">
                    <c:v>0.0135985282752588</c:v>
                  </c:pt>
                  <c:pt idx="7">
                    <c:v>0.0359945815489862</c:v>
                  </c:pt>
                  <c:pt idx="8">
                    <c:v>0.0245260819671883</c:v>
                  </c:pt>
                  <c:pt idx="9">
                    <c:v>0.02164533189345</c:v>
                  </c:pt>
                  <c:pt idx="10">
                    <c:v>0.0554750790651541</c:v>
                  </c:pt>
                  <c:pt idx="11">
                    <c:v>0.0213511944719822</c:v>
                  </c:pt>
                  <c:pt idx="12">
                    <c:v>0.0483093649045109</c:v>
                  </c:pt>
                </c:numCache>
              </c:numRef>
            </c:plus>
            <c:minus>
              <c:numLit>
                <c:ptCount val="0"/>
              </c:numLit>
            </c:minus>
          </c:errBars>
          <c:cat>
            <c:strRef>
              <c:f>'20110106qPCR Pst hrc 6hpi'!$M$10:$M$22</c:f>
              <c:strCache>
                <c:ptCount val="13"/>
                <c:pt idx="0">
                  <c:v>TRV</c:v>
                </c:pt>
                <c:pt idx="1">
                  <c:v>S3A-3</c:v>
                </c:pt>
                <c:pt idx="2">
                  <c:v>S3A-4</c:v>
                </c:pt>
                <c:pt idx="3">
                  <c:v>S3A-5</c:v>
                </c:pt>
                <c:pt idx="4">
                  <c:v>S3A-6</c:v>
                </c:pt>
                <c:pt idx="5">
                  <c:v>S3B-3</c:v>
                </c:pt>
                <c:pt idx="6">
                  <c:v>S3B-4</c:v>
                </c:pt>
                <c:pt idx="7">
                  <c:v>S3B-5</c:v>
                </c:pt>
                <c:pt idx="8">
                  <c:v>S3B-6</c:v>
                </c:pt>
                <c:pt idx="9">
                  <c:v>S3AB-3</c:v>
                </c:pt>
                <c:pt idx="10">
                  <c:v>S3AB-4</c:v>
                </c:pt>
                <c:pt idx="11">
                  <c:v>S3AB-5</c:v>
                </c:pt>
                <c:pt idx="12">
                  <c:v>S3AB-6</c:v>
                </c:pt>
              </c:strCache>
            </c:strRef>
          </c:cat>
          <c:val>
            <c:numRef>
              <c:f>'20110106qPCR Pst hrc 6hpi'!$O$10:$O$22</c:f>
              <c:numCache>
                <c:formatCode>General</c:formatCode>
                <c:ptCount val="13"/>
                <c:pt idx="0">
                  <c:v>1.005409967339339</c:v>
                </c:pt>
                <c:pt idx="1">
                  <c:v>0.90341637208928</c:v>
                </c:pt>
                <c:pt idx="2">
                  <c:v>0.836272618750505</c:v>
                </c:pt>
                <c:pt idx="3">
                  <c:v>0.938080669547548</c:v>
                </c:pt>
                <c:pt idx="4">
                  <c:v>0.812740256575233</c:v>
                </c:pt>
                <c:pt idx="5">
                  <c:v>0.268104299488653</c:v>
                </c:pt>
                <c:pt idx="6">
                  <c:v>0.392527669902858</c:v>
                </c:pt>
                <c:pt idx="7">
                  <c:v>0.261307197201694</c:v>
                </c:pt>
                <c:pt idx="8">
                  <c:v>0.354403059660412</c:v>
                </c:pt>
                <c:pt idx="9">
                  <c:v>0.208933716503036</c:v>
                </c:pt>
                <c:pt idx="10">
                  <c:v>0.270612938376237</c:v>
                </c:pt>
                <c:pt idx="11">
                  <c:v>0.30852578322124</c:v>
                </c:pt>
                <c:pt idx="12">
                  <c:v>0.2815676127887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9083224"/>
        <c:axId val="-2143087336"/>
      </c:barChart>
      <c:catAx>
        <c:axId val="212908322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-2143087336"/>
        <c:crosses val="autoZero"/>
        <c:auto val="1"/>
        <c:lblAlgn val="ctr"/>
        <c:lblOffset val="100"/>
        <c:noMultiLvlLbl val="0"/>
      </c:catAx>
      <c:valAx>
        <c:axId val="-214308733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Relative amount</a:t>
                </a:r>
              </a:p>
            </c:rich>
          </c:tx>
          <c:layout>
            <c:manualLayout>
              <c:xMode val="edge"/>
              <c:yMode val="edge"/>
              <c:x val="0.0312709973753281"/>
              <c:y val="0.24854148439778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crossAx val="21290832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297375328084"/>
          <c:y val="0.0302099737532808"/>
          <c:w val="0.194715223097113"/>
          <c:h val="0.167357611548556"/>
        </c:manualLayout>
      </c:layout>
      <c:overlay val="0"/>
      <c:txPr>
        <a:bodyPr/>
        <a:lstStyle/>
        <a:p>
          <a:pPr>
            <a:defRPr i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Helvetica"/>
          <a:cs typeface="Helvetica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660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678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017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480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566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5884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544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490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166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340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378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E3750-FA73-4741-BEAE-78CBA1591E0C}" type="datetimeFigureOut">
              <a:rPr lang="en-US" smtClean="0"/>
              <a:t>3/7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272F8E-8645-0245-A242-35C4DAB49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949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microsoft.com/office/2007/relationships/hdphoto" Target="../media/hdphoto1.wdp"/><Relationship Id="rId5" Type="http://schemas.openxmlformats.org/officeDocument/2006/relationships/image" Target="../media/image2.jpeg"/><Relationship Id="rId6" Type="http://schemas.microsoft.com/office/2007/relationships/hdphoto" Target="../media/hdphoto2.wdp"/><Relationship Id="rId7" Type="http://schemas.openxmlformats.org/officeDocument/2006/relationships/image" Target="../media/image3.jpeg"/><Relationship Id="rId8" Type="http://schemas.microsoft.com/office/2007/relationships/hdphoto" Target="../media/hdphoto3.wdp"/><Relationship Id="rId9" Type="http://schemas.openxmlformats.org/officeDocument/2006/relationships/image" Target="../media/image4.jpeg"/><Relationship Id="rId10" Type="http://schemas.microsoft.com/office/2007/relationships/hdphoto" Target="../media/hdphoto4.wdp"/><Relationship Id="rId11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2" name="Chart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6839065"/>
              </p:ext>
            </p:extLst>
          </p:nvPr>
        </p:nvGraphicFramePr>
        <p:xfrm>
          <a:off x="1148636" y="53286"/>
          <a:ext cx="4572000" cy="3060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1107365" y="3040005"/>
            <a:ext cx="4688683" cy="1989423"/>
            <a:chOff x="293867" y="2770205"/>
            <a:chExt cx="6699240" cy="2731806"/>
          </a:xfrm>
        </p:grpSpPr>
        <p:pic>
          <p:nvPicPr>
            <p:cNvPr id="4" name="Picture 3" descr="TRV-SlSERK3A.JPG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895526" y="2779060"/>
              <a:ext cx="1509454" cy="2365915"/>
            </a:xfrm>
            <a:prstGeom prst="rect">
              <a:avLst/>
            </a:prstGeom>
          </p:spPr>
        </p:pic>
        <p:pic>
          <p:nvPicPr>
            <p:cNvPr id="5" name="Picture 4" descr="TRV-SlSERK3B.JPG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96334" y="2779060"/>
              <a:ext cx="1509454" cy="2365915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554331" y="5121647"/>
              <a:ext cx="1061099" cy="3363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TRV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625630" y="5121646"/>
              <a:ext cx="1807443" cy="380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TRV-</a:t>
              </a:r>
              <a:r>
                <a:rPr lang="en-US" sz="1200" i="1" dirty="0" smtClean="0">
                  <a:latin typeface="Helvetica"/>
                  <a:cs typeface="Helvetica"/>
                </a:rPr>
                <a:t>SlSERK3A</a:t>
              </a:r>
              <a:endParaRPr lang="en-US" sz="1200" i="1" dirty="0">
                <a:latin typeface="Helvetica"/>
                <a:cs typeface="Helvetica"/>
              </a:endParaRPr>
            </a:p>
          </p:txBody>
        </p:sp>
        <p:pic>
          <p:nvPicPr>
            <p:cNvPr id="2" name="Picture 1" descr="TRV.JPG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3867" y="2779060"/>
              <a:ext cx="1509454" cy="2365915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3286388" y="5121647"/>
              <a:ext cx="1842710" cy="3803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TRV-</a:t>
              </a:r>
              <a:r>
                <a:rPr lang="en-US" sz="1200" i="1" dirty="0" smtClean="0">
                  <a:latin typeface="Helvetica"/>
                  <a:cs typeface="Helvetica"/>
                </a:rPr>
                <a:t>SlSERK3B</a:t>
              </a:r>
              <a:endParaRPr lang="en-US" sz="1200" i="1" dirty="0">
                <a:latin typeface="Helvetica"/>
                <a:cs typeface="Helvetica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982503" y="5106204"/>
              <a:ext cx="2010604" cy="3803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TRV-</a:t>
              </a:r>
              <a:r>
                <a:rPr lang="en-US" sz="1200" i="1" dirty="0" smtClean="0">
                  <a:latin typeface="Helvetica"/>
                  <a:cs typeface="Helvetica"/>
                </a:rPr>
                <a:t>SlSERK3AB</a:t>
              </a:r>
              <a:endParaRPr lang="en-US" sz="1200" i="1" dirty="0">
                <a:latin typeface="Helvetica"/>
                <a:cs typeface="Helvetica"/>
              </a:endParaRPr>
            </a:p>
          </p:txBody>
        </p:sp>
        <p:pic>
          <p:nvPicPr>
            <p:cNvPr id="12" name="Picture 11" descr="DSC03295_DxO.jpg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095365" y="2770205"/>
              <a:ext cx="1509454" cy="2374770"/>
            </a:xfrm>
            <a:prstGeom prst="rect">
              <a:avLst/>
            </a:prstGeom>
          </p:spPr>
        </p:pic>
      </p:grpSp>
      <p:sp>
        <p:nvSpPr>
          <p:cNvPr id="7" name="Rectangle 6"/>
          <p:cNvSpPr/>
          <p:nvPr/>
        </p:nvSpPr>
        <p:spPr>
          <a:xfrm>
            <a:off x="1143000" y="2208630"/>
            <a:ext cx="5444067" cy="852488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 rot="18938170">
            <a:off x="1163084" y="2418177"/>
            <a:ext cx="1041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5" name="TextBox 14"/>
          <p:cNvSpPr txBox="1"/>
          <p:nvPr/>
        </p:nvSpPr>
        <p:spPr>
          <a:xfrm rot="18938170">
            <a:off x="1295740" y="2467158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</a:t>
            </a:r>
            <a:r>
              <a:rPr lang="en-US" sz="1000" dirty="0" smtClean="0">
                <a:latin typeface="Helvetica"/>
                <a:cs typeface="Helvetica"/>
              </a:rPr>
              <a:t>-3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7" name="TextBox 16"/>
          <p:cNvSpPr txBox="1"/>
          <p:nvPr/>
        </p:nvSpPr>
        <p:spPr>
          <a:xfrm rot="18938170">
            <a:off x="1575138" y="2464400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</a:t>
            </a:r>
            <a:r>
              <a:rPr lang="en-US" sz="1000" dirty="0" smtClean="0">
                <a:latin typeface="Helvetica"/>
                <a:cs typeface="Helvetica"/>
              </a:rPr>
              <a:t>-4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8" name="TextBox 17"/>
          <p:cNvSpPr txBox="1"/>
          <p:nvPr/>
        </p:nvSpPr>
        <p:spPr>
          <a:xfrm rot="18938170">
            <a:off x="1863806" y="2467159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</a:t>
            </a:r>
            <a:r>
              <a:rPr lang="en-US" sz="1000" dirty="0" smtClean="0">
                <a:latin typeface="Helvetica"/>
                <a:cs typeface="Helvetica"/>
              </a:rPr>
              <a:t>-5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19" name="TextBox 18"/>
          <p:cNvSpPr txBox="1"/>
          <p:nvPr/>
        </p:nvSpPr>
        <p:spPr>
          <a:xfrm rot="18938170">
            <a:off x="2448017" y="2464401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B</a:t>
            </a:r>
            <a:r>
              <a:rPr lang="en-US" sz="1000" dirty="0" smtClean="0">
                <a:latin typeface="Helvetica"/>
                <a:cs typeface="Helvetica"/>
              </a:rPr>
              <a:t>-3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0" name="TextBox 19"/>
          <p:cNvSpPr txBox="1"/>
          <p:nvPr/>
        </p:nvSpPr>
        <p:spPr>
          <a:xfrm rot="18938170">
            <a:off x="2729907" y="2467158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B</a:t>
            </a:r>
            <a:r>
              <a:rPr lang="en-US" sz="1000" dirty="0" smtClean="0">
                <a:latin typeface="Helvetica"/>
                <a:cs typeface="Helvetica"/>
              </a:rPr>
              <a:t>-4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 rot="18938170">
            <a:off x="3026239" y="2472867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B</a:t>
            </a:r>
            <a:r>
              <a:rPr lang="en-US" sz="1000" dirty="0" smtClean="0">
                <a:latin typeface="Helvetica"/>
                <a:cs typeface="Helvetica"/>
              </a:rPr>
              <a:t>-5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2" name="TextBox 21"/>
          <p:cNvSpPr txBox="1"/>
          <p:nvPr/>
        </p:nvSpPr>
        <p:spPr>
          <a:xfrm rot="18938170">
            <a:off x="2126022" y="2467157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</a:t>
            </a:r>
            <a:r>
              <a:rPr lang="en-US" sz="1000" dirty="0" smtClean="0">
                <a:latin typeface="Helvetica"/>
                <a:cs typeface="Helvetica"/>
              </a:rPr>
              <a:t>-6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3" name="TextBox 22"/>
          <p:cNvSpPr txBox="1"/>
          <p:nvPr/>
        </p:nvSpPr>
        <p:spPr>
          <a:xfrm rot="18938170">
            <a:off x="3281039" y="2467158"/>
            <a:ext cx="12299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B</a:t>
            </a:r>
            <a:r>
              <a:rPr lang="en-US" sz="1000" dirty="0" smtClean="0">
                <a:latin typeface="Helvetica"/>
                <a:cs typeface="Helvetica"/>
              </a:rPr>
              <a:t>-6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4" name="TextBox 23"/>
          <p:cNvSpPr txBox="1"/>
          <p:nvPr/>
        </p:nvSpPr>
        <p:spPr>
          <a:xfrm rot="18938170">
            <a:off x="3480592" y="2510069"/>
            <a:ext cx="1352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B</a:t>
            </a:r>
            <a:r>
              <a:rPr lang="en-US" sz="1000" dirty="0" smtClean="0">
                <a:latin typeface="Helvetica"/>
                <a:cs typeface="Helvetica"/>
              </a:rPr>
              <a:t>-3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5" name="TextBox 24"/>
          <p:cNvSpPr txBox="1"/>
          <p:nvPr/>
        </p:nvSpPr>
        <p:spPr>
          <a:xfrm rot="18938170">
            <a:off x="3760034" y="2512185"/>
            <a:ext cx="1352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B</a:t>
            </a:r>
            <a:r>
              <a:rPr lang="en-US" sz="1000" dirty="0" smtClean="0">
                <a:latin typeface="Helvetica"/>
                <a:cs typeface="Helvetica"/>
              </a:rPr>
              <a:t>-4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6" name="TextBox 25"/>
          <p:cNvSpPr txBox="1"/>
          <p:nvPr/>
        </p:nvSpPr>
        <p:spPr>
          <a:xfrm rot="18938170">
            <a:off x="4045451" y="2508829"/>
            <a:ext cx="1352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B</a:t>
            </a:r>
            <a:r>
              <a:rPr lang="en-US" sz="1000" dirty="0" smtClean="0">
                <a:latin typeface="Helvetica"/>
                <a:cs typeface="Helvetica"/>
              </a:rPr>
              <a:t>-5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7" name="TextBox 26"/>
          <p:cNvSpPr txBox="1"/>
          <p:nvPr/>
        </p:nvSpPr>
        <p:spPr>
          <a:xfrm rot="18938170">
            <a:off x="4344356" y="2508830"/>
            <a:ext cx="1352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Helvetica"/>
                <a:cs typeface="Helvetica"/>
              </a:rPr>
              <a:t>TRV-</a:t>
            </a:r>
            <a:r>
              <a:rPr lang="en-US" sz="1000" i="1" dirty="0" smtClean="0">
                <a:latin typeface="Helvetica"/>
                <a:cs typeface="Helvetica"/>
              </a:rPr>
              <a:t>SlSERK3AB</a:t>
            </a:r>
            <a:r>
              <a:rPr lang="en-US" sz="1000" dirty="0" smtClean="0">
                <a:latin typeface="Helvetica"/>
                <a:cs typeface="Helvetica"/>
              </a:rPr>
              <a:t>-6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170618" y="6405425"/>
            <a:ext cx="1389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V-</a:t>
            </a:r>
            <a:r>
              <a:rPr lang="en-US" sz="1200" i="1" dirty="0" smtClean="0">
                <a:latin typeface="Helvetica"/>
                <a:cs typeface="Helvetica"/>
              </a:rPr>
              <a:t>SlSERK3</a:t>
            </a:r>
            <a:r>
              <a:rPr lang="en-US" sz="1200" dirty="0" smtClean="0">
                <a:latin typeface="Helvetica"/>
                <a:cs typeface="Helvetica"/>
              </a:rPr>
              <a:t>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600981" y="6405425"/>
            <a:ext cx="1389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V-</a:t>
            </a:r>
            <a:r>
              <a:rPr lang="en-US" sz="1200" i="1" dirty="0" smtClean="0">
                <a:latin typeface="Helvetica"/>
                <a:cs typeface="Helvetica"/>
              </a:rPr>
              <a:t>SlSERK3B</a:t>
            </a:r>
            <a:endParaRPr lang="en-US" sz="1200" i="1" dirty="0">
              <a:latin typeface="Helvetica"/>
              <a:cs typeface="Helvetica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65177" y="-52607"/>
            <a:ext cx="52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65177" y="2809769"/>
            <a:ext cx="52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3200" y="4895753"/>
            <a:ext cx="522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Helvetica"/>
                <a:cs typeface="Helvetica"/>
              </a:rPr>
              <a:t>C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404692" y="1459330"/>
            <a:ext cx="1144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363928" y="1663959"/>
            <a:ext cx="1144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48128" y="1639988"/>
            <a:ext cx="1144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207934" y="1549659"/>
            <a:ext cx="287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620469" y="1503780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950937" y="1626890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627609" y="1819851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 </a:t>
            </a:r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039444" y="1781751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Helvetica"/>
                <a:cs typeface="Helvetica"/>
              </a:rPr>
              <a:t> </a:t>
            </a:r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417485" y="1711900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491591" y="1730950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708538" y="1578550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790041" y="1605379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994288" y="1692850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079700" y="1614189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280038" y="1686500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364535" y="1605379"/>
            <a:ext cx="353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Helvetica"/>
                <a:cs typeface="Helvetica"/>
              </a:rPr>
              <a:t>*</a:t>
            </a:r>
            <a:endParaRPr lang="en-US" sz="1000" dirty="0">
              <a:latin typeface="Helvetica"/>
              <a:cs typeface="Helvetica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918349" y="6399418"/>
            <a:ext cx="1389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flg22</a:t>
            </a:r>
            <a:endParaRPr lang="en-US" sz="1200" i="1" dirty="0">
              <a:latin typeface="Helvetica"/>
              <a:cs typeface="Helvetica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41812" y="6768737"/>
            <a:ext cx="6213809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Arial"/>
                <a:cs typeface="Arial"/>
              </a:rPr>
              <a:t>Figure </a:t>
            </a:r>
            <a:r>
              <a:rPr lang="en-US" sz="1200" b="1" dirty="0">
                <a:latin typeface="Arial"/>
                <a:cs typeface="Arial"/>
              </a:rPr>
              <a:t>S4.</a:t>
            </a:r>
            <a:r>
              <a:rPr lang="en-US" sz="1200" dirty="0">
                <a:latin typeface="Arial"/>
                <a:cs typeface="Arial"/>
              </a:rPr>
              <a:t> Silencing individually </a:t>
            </a:r>
            <a:r>
              <a:rPr lang="en-US" sz="1200" i="1" dirty="0">
                <a:latin typeface="Arial"/>
                <a:cs typeface="Arial"/>
              </a:rPr>
              <a:t>SlSERK3A </a:t>
            </a:r>
            <a:r>
              <a:rPr lang="en-US" sz="1200" dirty="0">
                <a:latin typeface="Arial"/>
                <a:cs typeface="Arial"/>
              </a:rPr>
              <a:t>or </a:t>
            </a:r>
            <a:r>
              <a:rPr lang="en-US" sz="1200" i="1" dirty="0">
                <a:latin typeface="Arial"/>
                <a:cs typeface="Arial"/>
              </a:rPr>
              <a:t>SlSERK3B</a:t>
            </a:r>
            <a:r>
              <a:rPr lang="en-US" sz="1200" dirty="0">
                <a:latin typeface="Arial"/>
                <a:cs typeface="Arial"/>
              </a:rPr>
              <a:t> does not result in cell death. </a:t>
            </a:r>
            <a:r>
              <a:rPr lang="en-US" sz="1200" dirty="0" smtClean="0">
                <a:latin typeface="Arial"/>
                <a:cs typeface="Arial"/>
              </a:rPr>
              <a:t>(A) </a:t>
            </a:r>
            <a:r>
              <a:rPr lang="en-US" sz="1200" dirty="0">
                <a:latin typeface="Arial"/>
                <a:cs typeface="Arial"/>
              </a:rPr>
              <a:t>Transcript levels of VIGS-silenced genes were evaluated using </a:t>
            </a:r>
            <a:r>
              <a:rPr lang="en-US" sz="1200" dirty="0" err="1">
                <a:latin typeface="Arial"/>
                <a:cs typeface="Arial"/>
              </a:rPr>
              <a:t>qRT</a:t>
            </a:r>
            <a:r>
              <a:rPr lang="en-US" sz="1200" dirty="0">
                <a:latin typeface="Arial"/>
                <a:cs typeface="Arial"/>
              </a:rPr>
              <a:t>-PCR. Additional samples (</a:t>
            </a:r>
            <a:r>
              <a:rPr lang="en-US" sz="1200" dirty="0" smtClean="0">
                <a:latin typeface="Arial"/>
                <a:cs typeface="Arial"/>
              </a:rPr>
              <a:t>to those presented </a:t>
            </a:r>
            <a:r>
              <a:rPr lang="en-US" sz="1200" smtClean="0">
                <a:latin typeface="Arial"/>
                <a:cs typeface="Arial"/>
              </a:rPr>
              <a:t>in Figure </a:t>
            </a:r>
            <a:r>
              <a:rPr lang="en-US" sz="1200" dirty="0" smtClean="0">
                <a:latin typeface="Arial"/>
                <a:cs typeface="Arial"/>
              </a:rPr>
              <a:t>3A) of </a:t>
            </a:r>
            <a:r>
              <a:rPr lang="en-US" sz="1200" dirty="0">
                <a:latin typeface="Arial"/>
                <a:cs typeface="Arial"/>
              </a:rPr>
              <a:t>tomato cv. Moneymaker </a:t>
            </a:r>
            <a:r>
              <a:rPr lang="en-US" sz="1200" dirty="0" smtClean="0">
                <a:latin typeface="Arial"/>
                <a:cs typeface="Arial"/>
              </a:rPr>
              <a:t>plants (used in the bacterial screens) </a:t>
            </a:r>
            <a:r>
              <a:rPr lang="en-US" sz="1200" dirty="0">
                <a:latin typeface="Arial"/>
                <a:cs typeface="Arial"/>
              </a:rPr>
              <a:t>treated with TRV empty vector (TRV), TRV-</a:t>
            </a:r>
            <a:r>
              <a:rPr lang="en-US" sz="1200" i="1" dirty="0">
                <a:latin typeface="Arial"/>
                <a:cs typeface="Arial"/>
              </a:rPr>
              <a:t>SlSERK3A, </a:t>
            </a:r>
            <a:r>
              <a:rPr lang="en-US" sz="1200" dirty="0">
                <a:latin typeface="Arial"/>
                <a:cs typeface="Arial"/>
              </a:rPr>
              <a:t>TRV-</a:t>
            </a:r>
            <a:r>
              <a:rPr lang="en-US" sz="1200" i="1" dirty="0" smtClean="0">
                <a:latin typeface="Arial"/>
                <a:cs typeface="Arial"/>
              </a:rPr>
              <a:t>SlSERK3B</a:t>
            </a:r>
            <a:r>
              <a:rPr lang="en-US" sz="1200" i="1" dirty="0">
                <a:latin typeface="Arial"/>
                <a:cs typeface="Arial"/>
              </a:rPr>
              <a:t>,</a:t>
            </a:r>
            <a:r>
              <a:rPr lang="en-US" sz="1200" i="1" dirty="0" smtClean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TRV-</a:t>
            </a:r>
            <a:r>
              <a:rPr lang="en-US" sz="1200" i="1" dirty="0" smtClean="0">
                <a:latin typeface="Arial"/>
                <a:cs typeface="Arial"/>
              </a:rPr>
              <a:t>SlSERK3AB </a:t>
            </a:r>
            <a:r>
              <a:rPr lang="en-US" sz="1200" dirty="0">
                <a:latin typeface="Arial"/>
                <a:cs typeface="Arial"/>
              </a:rPr>
              <a:t>were evaluated</a:t>
            </a:r>
            <a:r>
              <a:rPr lang="en-US" sz="1200" i="1" dirty="0">
                <a:latin typeface="Arial"/>
                <a:cs typeface="Arial"/>
              </a:rPr>
              <a:t>. </a:t>
            </a:r>
            <a:r>
              <a:rPr lang="en-US" sz="1200" dirty="0">
                <a:latin typeface="Arial"/>
                <a:cs typeface="Arial"/>
              </a:rPr>
              <a:t>Expression was normalized against </a:t>
            </a:r>
            <a:r>
              <a:rPr lang="en-US" sz="1200" i="1" dirty="0">
                <a:latin typeface="Arial"/>
                <a:cs typeface="Arial"/>
              </a:rPr>
              <a:t>UBI3. </a:t>
            </a:r>
            <a:r>
              <a:rPr lang="en-US" sz="1200" dirty="0">
                <a:latin typeface="Arial"/>
                <a:cs typeface="Arial"/>
              </a:rPr>
              <a:t>Values </a:t>
            </a:r>
            <a:r>
              <a:rPr lang="en-US" sz="1200" dirty="0" smtClean="0">
                <a:latin typeface="Arial"/>
                <a:cs typeface="Arial"/>
              </a:rPr>
              <a:t>represent expression in individual leaflets and average </a:t>
            </a:r>
            <a:r>
              <a:rPr lang="en-US" sz="1200" u="sng" dirty="0">
                <a:latin typeface="Arial"/>
                <a:cs typeface="Arial"/>
              </a:rPr>
              <a:t>+</a:t>
            </a:r>
            <a:r>
              <a:rPr lang="en-US" sz="1200" dirty="0">
                <a:latin typeface="Arial"/>
                <a:cs typeface="Arial"/>
              </a:rPr>
              <a:t> SE of three technical replicates. *</a:t>
            </a:r>
            <a:r>
              <a:rPr lang="en-US" sz="1200" i="1" dirty="0">
                <a:latin typeface="Arial"/>
                <a:cs typeface="Arial"/>
              </a:rPr>
              <a:t>P </a:t>
            </a:r>
            <a:r>
              <a:rPr lang="en-US" sz="1200" dirty="0">
                <a:latin typeface="Arial"/>
                <a:cs typeface="Arial"/>
              </a:rPr>
              <a:t>&lt; 0.05 significant difference from TRV (two-sample </a:t>
            </a:r>
            <a:r>
              <a:rPr lang="en-US" sz="1200" i="1" dirty="0">
                <a:latin typeface="Arial"/>
                <a:cs typeface="Arial"/>
              </a:rPr>
              <a:t>t</a:t>
            </a:r>
            <a:r>
              <a:rPr lang="en-US" sz="1200" dirty="0">
                <a:latin typeface="Arial"/>
                <a:cs typeface="Arial"/>
              </a:rPr>
              <a:t>-test). Experiment was repeated three times with similar results. </a:t>
            </a:r>
            <a:r>
              <a:rPr lang="en-US" sz="1200" dirty="0" smtClean="0">
                <a:latin typeface="Arial"/>
                <a:cs typeface="Arial"/>
              </a:rPr>
              <a:t>(B) Tomato </a:t>
            </a:r>
            <a:r>
              <a:rPr lang="en-US" sz="1200" dirty="0">
                <a:latin typeface="Arial"/>
                <a:cs typeface="Arial"/>
              </a:rPr>
              <a:t>cv. Moneymaker leaflets from plants silenced with the indicated TRV constructs. Photos were taken 3 weeks after TRV treatment. </a:t>
            </a:r>
            <a:r>
              <a:rPr lang="en-US" sz="1200" dirty="0" smtClean="0">
                <a:latin typeface="Arial"/>
                <a:cs typeface="Arial"/>
              </a:rPr>
              <a:t>(C) Aniline </a:t>
            </a:r>
            <a:r>
              <a:rPr lang="en-US" sz="1200" dirty="0">
                <a:latin typeface="Arial"/>
                <a:cs typeface="Arial"/>
              </a:rPr>
              <a:t>blue-stained tomato leaf discs. No </a:t>
            </a:r>
            <a:r>
              <a:rPr lang="en-US" sz="1200" dirty="0" err="1" smtClean="0">
                <a:latin typeface="Arial"/>
                <a:cs typeface="Arial"/>
              </a:rPr>
              <a:t>callose</a:t>
            </a:r>
            <a:r>
              <a:rPr lang="en-US" sz="1200" dirty="0" smtClean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deposits were detected in leaflets silenced for either </a:t>
            </a:r>
            <a:r>
              <a:rPr lang="en-US" sz="1200" i="1" dirty="0">
                <a:latin typeface="Arial"/>
                <a:cs typeface="Arial"/>
              </a:rPr>
              <a:t>SlSERK3A</a:t>
            </a:r>
            <a:r>
              <a:rPr lang="en-US" sz="1200" dirty="0">
                <a:latin typeface="Arial"/>
                <a:cs typeface="Arial"/>
              </a:rPr>
              <a:t> or </a:t>
            </a:r>
            <a:r>
              <a:rPr lang="en-US" sz="1200" i="1" dirty="0" smtClean="0">
                <a:latin typeface="Arial"/>
                <a:cs typeface="Arial"/>
              </a:rPr>
              <a:t>SlSERK3B</a:t>
            </a:r>
            <a:r>
              <a:rPr lang="en-US" sz="1200" dirty="0" smtClean="0">
                <a:latin typeface="Arial"/>
                <a:cs typeface="Arial"/>
              </a:rPr>
              <a:t>.</a:t>
            </a:r>
            <a:r>
              <a:rPr lang="en-US" sz="1200" i="1" dirty="0" smtClean="0">
                <a:latin typeface="Arial"/>
                <a:cs typeface="Arial"/>
              </a:rPr>
              <a:t> </a:t>
            </a:r>
            <a:r>
              <a:rPr lang="en-US" sz="1200" dirty="0">
                <a:latin typeface="Arial"/>
                <a:cs typeface="Arial"/>
              </a:rPr>
              <a:t>Leaves treated with 1 </a:t>
            </a:r>
            <a:r>
              <a:rPr lang="en-US" sz="1200" dirty="0" err="1">
                <a:latin typeface="Arial"/>
                <a:cs typeface="Arial"/>
              </a:rPr>
              <a:t>mM</a:t>
            </a:r>
            <a:r>
              <a:rPr lang="en-US" sz="1200" dirty="0">
                <a:latin typeface="Arial"/>
                <a:cs typeface="Arial"/>
              </a:rPr>
              <a:t> flg22 for 24 h were used as </a:t>
            </a:r>
            <a:r>
              <a:rPr lang="en-US" sz="1200" dirty="0" smtClean="0">
                <a:latin typeface="Arial"/>
                <a:cs typeface="Arial"/>
              </a:rPr>
              <a:t>control.</a:t>
            </a:r>
            <a:endParaRPr lang="en-US" sz="1200" dirty="0">
              <a:latin typeface="Arial"/>
              <a:cs typeface="Arial"/>
            </a:endParaRPr>
          </a:p>
        </p:txBody>
      </p:sp>
      <p:pic>
        <p:nvPicPr>
          <p:cNvPr id="57" name="Picture 5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38946" y="5152480"/>
            <a:ext cx="3958717" cy="1270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7028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560</TotalTime>
  <Words>291</Words>
  <Application>Microsoft Macintosh PowerPoint</Application>
  <PresentationFormat>Letter Paper (8.5x11 in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UANCHIEH PENG</dc:creator>
  <cp:lastModifiedBy>Isgouhi Kaloshian</cp:lastModifiedBy>
  <cp:revision>29</cp:revision>
  <dcterms:created xsi:type="dcterms:W3CDTF">2013-07-16T01:13:00Z</dcterms:created>
  <dcterms:modified xsi:type="dcterms:W3CDTF">2014-03-08T00:59:32Z</dcterms:modified>
</cp:coreProperties>
</file>